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89463" autoAdjust="0"/>
  </p:normalViewPr>
  <p:slideViewPr>
    <p:cSldViewPr snapToGrid="0">
      <p:cViewPr varScale="1">
        <p:scale>
          <a:sx n="101" d="100"/>
          <a:sy n="101" d="100"/>
        </p:scale>
        <p:origin x="24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hart&#10;&#10;AI-generated content may be incorrect.">
            <a:extLst>
              <a:ext uri="{FF2B5EF4-FFF2-40B4-BE49-F238E27FC236}">
                <a16:creationId xmlns:a16="http://schemas.microsoft.com/office/drawing/2014/main" id="{4006698F-1100-589A-1582-DC98E9E980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813" y="0"/>
            <a:ext cx="237205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B1BAA4-F7C4-8E71-4323-4D2234D993A4}"/>
              </a:ext>
            </a:extLst>
          </p:cNvPr>
          <p:cNvSpPr txBox="1"/>
          <p:nvPr/>
        </p:nvSpPr>
        <p:spPr>
          <a:xfrm>
            <a:off x="3590144" y="156520"/>
            <a:ext cx="7852556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ull Ingenuity Pathway Analysis (IPA) network of enriched pathways derived from DMP-associated genes from the comparison C2D5 v.s. C1D1. Orange indicates activated pathways and blue indicates suppressed pathways (|z| &gt; 2). Gray represents weak or no effect, with no predicted direction of change, and white indicates insufficient data to predict pathway activity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9911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00</TotalTime>
  <Words>6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MDPI</cp:lastModifiedBy>
  <cp:revision>103</cp:revision>
  <cp:lastPrinted>2025-11-20T14:34:39Z</cp:lastPrinted>
  <dcterms:created xsi:type="dcterms:W3CDTF">2025-04-15T14:41:30Z</dcterms:created>
  <dcterms:modified xsi:type="dcterms:W3CDTF">2026-03-26T07:41:24Z</dcterms:modified>
</cp:coreProperties>
</file>